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410" r:id="rId5"/>
    <p:sldId id="414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C4D56F6-F4C4-41ED-952C-BCE3DE9640C1}" v="20" dt="2022-02-19T15:48:41.206"/>
    <p1510:client id="{DEC83E0E-F867-4160-9923-ABBB69BDC7F6}" v="10" dt="2022-02-21T22:07:45.77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0" d="100"/>
          <a:sy n="110" d="100"/>
        </p:scale>
        <p:origin x="492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Waikel, Rebekah (NIH/NHGRI) [E]" userId="S::waikelrl@nih.gov::20c0d6a4-60db-4ce1-ae9d-87c5ec5746be" providerId="AD" clId="Web-{5C4D56F6-F4C4-41ED-952C-BCE3DE9640C1}"/>
    <pc:docChg chg="modSld">
      <pc:chgData name="Waikel, Rebekah (NIH/NHGRI) [E]" userId="S::waikelrl@nih.gov::20c0d6a4-60db-4ce1-ae9d-87c5ec5746be" providerId="AD" clId="Web-{5C4D56F6-F4C4-41ED-952C-BCE3DE9640C1}" dt="2022-02-19T15:48:36.972" v="18" actId="20577"/>
      <pc:docMkLst>
        <pc:docMk/>
      </pc:docMkLst>
      <pc:sldChg chg="modSp">
        <pc:chgData name="Waikel, Rebekah (NIH/NHGRI) [E]" userId="S::waikelrl@nih.gov::20c0d6a4-60db-4ce1-ae9d-87c5ec5746be" providerId="AD" clId="Web-{5C4D56F6-F4C4-41ED-952C-BCE3DE9640C1}" dt="2022-02-19T15:48:36.972" v="18" actId="20577"/>
        <pc:sldMkLst>
          <pc:docMk/>
          <pc:sldMk cId="1499633700" sldId="410"/>
        </pc:sldMkLst>
        <pc:spChg chg="mod">
          <ac:chgData name="Waikel, Rebekah (NIH/NHGRI) [E]" userId="S::waikelrl@nih.gov::20c0d6a4-60db-4ce1-ae9d-87c5ec5746be" providerId="AD" clId="Web-{5C4D56F6-F4C4-41ED-952C-BCE3DE9640C1}" dt="2022-02-19T15:48:36.972" v="18" actId="20577"/>
          <ac:spMkLst>
            <pc:docMk/>
            <pc:sldMk cId="1499633700" sldId="410"/>
            <ac:spMk id="12" creationId="{854F8B58-D9D8-4F91-AAC7-2EA5E880745E}"/>
          </ac:spMkLst>
        </pc:spChg>
      </pc:sldChg>
    </pc:docChg>
  </pc:docChgLst>
  <pc:docChgLst>
    <pc:chgData name="Waikel, Rebekah (NIH/NHGRI) [E]" userId="S::waikelrl@nih.gov::20c0d6a4-60db-4ce1-ae9d-87c5ec5746be" providerId="AD" clId="Web-{DEC83E0E-F867-4160-9923-ABBB69BDC7F6}"/>
    <pc:docChg chg="modSld">
      <pc:chgData name="Waikel, Rebekah (NIH/NHGRI) [E]" userId="S::waikelrl@nih.gov::20c0d6a4-60db-4ce1-ae9d-87c5ec5746be" providerId="AD" clId="Web-{DEC83E0E-F867-4160-9923-ABBB69BDC7F6}" dt="2022-02-21T22:07:45.772" v="10" actId="20577"/>
      <pc:docMkLst>
        <pc:docMk/>
      </pc:docMkLst>
      <pc:sldChg chg="modSp">
        <pc:chgData name="Waikel, Rebekah (NIH/NHGRI) [E]" userId="S::waikelrl@nih.gov::20c0d6a4-60db-4ce1-ae9d-87c5ec5746be" providerId="AD" clId="Web-{DEC83E0E-F867-4160-9923-ABBB69BDC7F6}" dt="2022-02-21T22:07:45.772" v="10" actId="20577"/>
        <pc:sldMkLst>
          <pc:docMk/>
          <pc:sldMk cId="1499633700" sldId="410"/>
        </pc:sldMkLst>
        <pc:spChg chg="mod">
          <ac:chgData name="Waikel, Rebekah (NIH/NHGRI) [E]" userId="S::waikelrl@nih.gov::20c0d6a4-60db-4ce1-ae9d-87c5ec5746be" providerId="AD" clId="Web-{DEC83E0E-F867-4160-9923-ABBB69BDC7F6}" dt="2022-02-21T22:07:45.772" v="10" actId="20577"/>
          <ac:spMkLst>
            <pc:docMk/>
            <pc:sldMk cId="1499633700" sldId="410"/>
            <ac:spMk id="12" creationId="{854F8B58-D9D8-4F91-AAC7-2EA5E880745E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AC94D8-D863-4FA5-BD52-9F7BBDD997D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CB3C8E6-2B12-455F-816C-26543120543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10EA90-1CA6-426C-BE56-2A4C742394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96FFFE-E22A-4890-8CCD-D2AC2E49E356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1E8D43-A736-4762-99F0-BEAB952040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C60422-E8C5-42BF-8DD2-81C5ACD69A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50711-51E0-4396-9D88-7DDCD8FD3A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71564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2B0FFD-9CFC-47AE-AB74-564374243E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B682E12-DA6F-4173-A501-E975030131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D9D997-9D1B-4A44-ACB1-96C525C880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96FFFE-E22A-4890-8CCD-D2AC2E49E356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A21AD7-45DA-4113-8605-4BDCFBCD88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55F7F4-666D-40C9-A92C-918A39683C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50711-51E0-4396-9D88-7DDCD8FD3A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81290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8BD4DA6-D497-4378-815B-FDD9D897074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F2F2668-DE79-4DE3-8090-DD6828B23D8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C16614-097A-4651-B69B-9A7AC7D882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96FFFE-E22A-4890-8CCD-D2AC2E49E356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895E08-4C56-4EB9-BD23-3F44F1CA13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8487DB-25BF-4F6B-A4D5-9DC2DD0F03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50711-51E0-4396-9D88-7DDCD8FD3A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47714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775FCB-E4A4-4E98-8B80-0DE4119F11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5EE2244-0CAD-4D42-8003-58078D97AF2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1625F1-8D6B-49BB-A2BB-3EB194F77D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96FFFE-E22A-4890-8CCD-D2AC2E49E356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7C9DFD-B04A-49C1-913A-9557871EBF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F402B6-ACAB-4746-A965-6414E8B25C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50711-51E0-4396-9D88-7DDCD8FD3A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94670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FE1F16-35CC-46BD-931E-C0ACBE86FE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F51725C-E01C-4275-B6FF-6C9E94C428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F0D677-18FB-4321-A00B-98B3E62D85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96FFFE-E22A-4890-8CCD-D2AC2E49E356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89DCF0-2FB0-492A-9731-91A64F9B4C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E59206-B9F9-4883-ABDB-36F1BABE1A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50711-51E0-4396-9D88-7DDCD8FD3A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09697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5E3AC3-E2F8-463A-A339-AFF623D9DD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E650641-D0EC-492E-8225-7B798F4B89A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A77C325-9BE1-40ED-805F-F55452E4A6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27E01D3-3EE3-4ED1-B99A-C119B7B3B5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96FFFE-E22A-4890-8CCD-D2AC2E49E356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77377B1-4985-4E65-9D6A-22BB37DE12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0AE216-A758-4080-B2B6-7A3890F090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50711-51E0-4396-9D88-7DDCD8FD3A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64212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B7F012-0464-4802-825F-087F372B4C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335B89E-2E71-4D6C-B259-C109344C51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660D2F9-8CB8-4998-8C3C-A7B009A89CA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53A508F-B123-4048-88A2-3A73DA38F31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4F0D3C8-7AE0-4ACA-BC60-7D4B075ECC0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72934E4-2A0B-493C-9402-7C21B580AE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96FFFE-E22A-4890-8CCD-D2AC2E49E356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46FE503-5B93-4168-A8FF-3A0F440808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680338D-7DA4-4000-9A08-D5EE62074C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50711-51E0-4396-9D88-7DDCD8FD3A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54330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0A5DBA-373C-4BA2-A424-CC60765C1A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DCF9F86-E915-405D-861D-7B29CA80C3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96FFFE-E22A-4890-8CCD-D2AC2E49E356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630A66E-7998-43E5-B57A-7C4FDCC204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50ABCC0-C4AA-47BB-BAD0-14ED2BC8B3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50711-51E0-4396-9D88-7DDCD8FD3A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24377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498124E-13D3-458A-8BF5-F4EA2719FF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96FFFE-E22A-4890-8CCD-D2AC2E49E356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5592670-25FF-4674-B631-05BEB7720B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A4DB7B8-9A99-432F-B65F-A353299B0E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50711-51E0-4396-9D88-7DDCD8FD3A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05093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1CE9A4-71BB-4C9B-9B16-6B3C59C47F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9724A2-1837-485F-B60D-E9E2C3D5758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6D4CA7A-B73D-4358-9D4B-73EB2D9D3D2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01AAC4C-F973-4D50-B5B9-861D686D40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96FFFE-E22A-4890-8CCD-D2AC2E49E356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B0BD852-69C8-4F8C-A759-C178A1E412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C7E166E-0930-41F0-95AE-1BD8F033F3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50711-51E0-4396-9D88-7DDCD8FD3A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1875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33BB10-E377-43AB-8E92-A47972F8D0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550AD51-54EF-4118-BF07-A7D9FF59325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ACD28A6-3A88-47C9-B7AC-5CBB0D5980E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0AEE6C-44CD-44A9-8851-675C44F754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96FFFE-E22A-4890-8CCD-D2AC2E49E356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7B7D1AC-EDBE-46A6-852F-40302BD44A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B395C1-1B89-4C8C-A7CB-891ABF8919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50711-51E0-4396-9D88-7DDCD8FD3A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24054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5E90903-4B43-44A6-A112-0959901860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6931F41-5FAD-45F9-9437-508083681D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675C0B-9CB0-433D-9A52-E45C2A0DEE0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96FFFE-E22A-4890-8CCD-D2AC2E49E356}" type="datetimeFigureOut">
              <a:rPr lang="en-US" smtClean="0"/>
              <a:t>2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332A7F-6B2B-467D-8840-4C6F7FD878D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F5FDF5-A0B5-4BCD-97FA-F3DFE89CFB8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950711-51E0-4396-9D88-7DDCD8FD3A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81547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11" Type="http://schemas.openxmlformats.org/officeDocument/2006/relationships/image" Target="../media/image20.png"/><Relationship Id="rId5" Type="http://schemas.openxmlformats.org/officeDocument/2006/relationships/image" Target="../media/image14.png"/><Relationship Id="rId10" Type="http://schemas.openxmlformats.org/officeDocument/2006/relationships/image" Target="../media/image19.png"/><Relationship Id="rId4" Type="http://schemas.openxmlformats.org/officeDocument/2006/relationships/image" Target="../media/image13.png"/><Relationship Id="rId9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Picture 49" descr="A picture containing person, indoor, posing, young&#10;&#10;Description automatically generated">
            <a:extLst>
              <a:ext uri="{FF2B5EF4-FFF2-40B4-BE49-F238E27FC236}">
                <a16:creationId xmlns:a16="http://schemas.microsoft.com/office/drawing/2014/main" id="{2A3BF715-6B71-47EC-8459-C448F5F58B2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142" y="404341"/>
            <a:ext cx="2127649" cy="2127649"/>
          </a:xfrm>
          <a:prstGeom prst="rect">
            <a:avLst/>
          </a:prstGeom>
        </p:spPr>
      </p:pic>
      <p:pic>
        <p:nvPicPr>
          <p:cNvPr id="53" name="Picture 52" descr="A picture containing person, indoor, young, posing&#10;&#10;Description automatically generated">
            <a:extLst>
              <a:ext uri="{FF2B5EF4-FFF2-40B4-BE49-F238E27FC236}">
                <a16:creationId xmlns:a16="http://schemas.microsoft.com/office/drawing/2014/main" id="{24EFBFA8-222B-4E71-9305-5A7823D1D14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0780" y="404341"/>
            <a:ext cx="2127649" cy="2127649"/>
          </a:xfrm>
          <a:prstGeom prst="rect">
            <a:avLst/>
          </a:prstGeom>
        </p:spPr>
      </p:pic>
      <p:pic>
        <p:nvPicPr>
          <p:cNvPr id="55" name="Picture 54" descr="A picture containing person, indoor, posing&#10;&#10;Description automatically generated">
            <a:extLst>
              <a:ext uri="{FF2B5EF4-FFF2-40B4-BE49-F238E27FC236}">
                <a16:creationId xmlns:a16="http://schemas.microsoft.com/office/drawing/2014/main" id="{26143619-F6D7-47DC-9E26-E2FD1F8604D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67418" y="404341"/>
            <a:ext cx="2127649" cy="2127649"/>
          </a:xfrm>
          <a:prstGeom prst="rect">
            <a:avLst/>
          </a:prstGeom>
        </p:spPr>
      </p:pic>
      <p:pic>
        <p:nvPicPr>
          <p:cNvPr id="57" name="Picture 56" descr="A person with dark hair&#10;&#10;Description automatically generated with low confidence">
            <a:extLst>
              <a:ext uri="{FF2B5EF4-FFF2-40B4-BE49-F238E27FC236}">
                <a16:creationId xmlns:a16="http://schemas.microsoft.com/office/drawing/2014/main" id="{B73765A6-164B-4604-8E77-AF049192FAC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05818" y="404341"/>
            <a:ext cx="2127649" cy="2127649"/>
          </a:xfrm>
          <a:prstGeom prst="rect">
            <a:avLst/>
          </a:prstGeom>
        </p:spPr>
      </p:pic>
      <p:pic>
        <p:nvPicPr>
          <p:cNvPr id="59" name="Picture 58" descr="A close up of a child&#10;&#10;Description automatically generated with medium confidence">
            <a:extLst>
              <a:ext uri="{FF2B5EF4-FFF2-40B4-BE49-F238E27FC236}">
                <a16:creationId xmlns:a16="http://schemas.microsoft.com/office/drawing/2014/main" id="{52F6ADE5-EC19-42BC-8FFB-DAE91589397D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44218" y="404341"/>
            <a:ext cx="2127649" cy="2127649"/>
          </a:xfrm>
          <a:prstGeom prst="rect">
            <a:avLst/>
          </a:prstGeom>
        </p:spPr>
      </p:pic>
      <p:pic>
        <p:nvPicPr>
          <p:cNvPr id="61" name="Picture 60" descr="A close-up of a baby&#10;&#10;Description automatically generated with medium confidence">
            <a:extLst>
              <a:ext uri="{FF2B5EF4-FFF2-40B4-BE49-F238E27FC236}">
                <a16:creationId xmlns:a16="http://schemas.microsoft.com/office/drawing/2014/main" id="{28F5276D-F8CF-4317-A4EC-CD6B01A33F6A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380" y="2984478"/>
            <a:ext cx="2127649" cy="2127649"/>
          </a:xfrm>
          <a:prstGeom prst="rect">
            <a:avLst/>
          </a:prstGeom>
        </p:spPr>
      </p:pic>
      <p:pic>
        <p:nvPicPr>
          <p:cNvPr id="63" name="Picture 62" descr="A close up of a baby&#10;&#10;Description automatically generated with medium confidence">
            <a:extLst>
              <a:ext uri="{FF2B5EF4-FFF2-40B4-BE49-F238E27FC236}">
                <a16:creationId xmlns:a16="http://schemas.microsoft.com/office/drawing/2014/main" id="{6E6AE328-DA5B-4B5D-968A-7290E9A962D5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9018" y="2984478"/>
            <a:ext cx="2127649" cy="2127649"/>
          </a:xfrm>
          <a:prstGeom prst="rect">
            <a:avLst/>
          </a:prstGeom>
        </p:spPr>
      </p:pic>
      <p:pic>
        <p:nvPicPr>
          <p:cNvPr id="65" name="Picture 64" descr="A picture containing person, indoor, posing&#10;&#10;Description automatically generated">
            <a:extLst>
              <a:ext uri="{FF2B5EF4-FFF2-40B4-BE49-F238E27FC236}">
                <a16:creationId xmlns:a16="http://schemas.microsoft.com/office/drawing/2014/main" id="{7BBA10B2-1D25-4D52-9949-75456AA65C09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75656" y="2984478"/>
            <a:ext cx="2127649" cy="2127649"/>
          </a:xfrm>
          <a:prstGeom prst="rect">
            <a:avLst/>
          </a:prstGeom>
        </p:spPr>
      </p:pic>
      <p:pic>
        <p:nvPicPr>
          <p:cNvPr id="67" name="Picture 66" descr="A close up of a person&#10;&#10;Description automatically generated with medium confidence">
            <a:extLst>
              <a:ext uri="{FF2B5EF4-FFF2-40B4-BE49-F238E27FC236}">
                <a16:creationId xmlns:a16="http://schemas.microsoft.com/office/drawing/2014/main" id="{11FE021B-661C-44BE-B3EE-D1C51D008A2D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22294" y="2984478"/>
            <a:ext cx="2127649" cy="2127649"/>
          </a:xfrm>
          <a:prstGeom prst="rect">
            <a:avLst/>
          </a:prstGeom>
        </p:spPr>
      </p:pic>
      <p:pic>
        <p:nvPicPr>
          <p:cNvPr id="69" name="Picture 68" descr="A picture containing person, indoor, wall, posing&#10;&#10;Description automatically generated">
            <a:extLst>
              <a:ext uri="{FF2B5EF4-FFF2-40B4-BE49-F238E27FC236}">
                <a16:creationId xmlns:a16="http://schemas.microsoft.com/office/drawing/2014/main" id="{33399E33-DC6D-434E-9760-838BC585FB14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44218" y="2984478"/>
            <a:ext cx="2127649" cy="2127649"/>
          </a:xfrm>
          <a:prstGeom prst="rect">
            <a:avLst/>
          </a:prstGeom>
        </p:spPr>
      </p:pic>
      <p:sp>
        <p:nvSpPr>
          <p:cNvPr id="12" name="Content Placeholder 2">
            <a:extLst>
              <a:ext uri="{FF2B5EF4-FFF2-40B4-BE49-F238E27FC236}">
                <a16:creationId xmlns:a16="http://schemas.microsoft.com/office/drawing/2014/main" id="{854F8B58-D9D8-4F91-AAC7-2EA5E880745E}"/>
              </a:ext>
            </a:extLst>
          </p:cNvPr>
          <p:cNvSpPr>
            <a:spLocks noGrp="1"/>
          </p:cNvSpPr>
          <p:nvPr/>
        </p:nvSpPr>
        <p:spPr>
          <a:xfrm>
            <a:off x="114802" y="5564615"/>
            <a:ext cx="11979397" cy="1143185"/>
          </a:xfrm>
          <a:prstGeom prst="rect">
            <a:avLst/>
          </a:prstGeom>
        </p:spPr>
        <p:txBody>
          <a:bodyPr vert="horz" lIns="91440" tIns="45720" rIns="91440" bIns="45720" rtlCol="0" anchor="t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  <a:defRPr/>
            </a:pPr>
            <a:r>
              <a:rPr lang="en-US" sz="1200" b="1" dirty="0">
                <a:latin typeface="Calibri" panose="020F0502020204030204"/>
              </a:rPr>
              <a:t>Supplementary Figure 3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.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Imperfect examples of type 2 and type 3 fake images.  The generation of type 2 and type 3 images using the same random vector in each age group can lead to imperfect images of 'individuals' with 22q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(a)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and WS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(b)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. For type 2 (top), general features, such as gender, skin tone and hair color, are not always preserved. For type 3 (bottom), the images look more consistent at depicting the same person progresses through different age groups; however, this progression is still imperfect. Also, because there are grayscale and color images in our training set, both type 2 and 3 images can show different color variations. 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4BB5318-9EAD-479D-A8BB-0D6FD511CB8C}"/>
              </a:ext>
            </a:extLst>
          </p:cNvPr>
          <p:cNvSpPr txBox="1"/>
          <p:nvPr/>
        </p:nvSpPr>
        <p:spPr>
          <a:xfrm>
            <a:off x="117199" y="38271"/>
            <a:ext cx="2743200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.</a:t>
            </a:r>
          </a:p>
        </p:txBody>
      </p:sp>
    </p:spTree>
    <p:extLst>
      <p:ext uri="{BB962C8B-B14F-4D97-AF65-F5344CB8AC3E}">
        <p14:creationId xmlns:p14="http://schemas.microsoft.com/office/powerpoint/2010/main" val="14996337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C39F8B79-E4C4-4F78-B860-7D5B821FF8BB}"/>
              </a:ext>
            </a:extLst>
          </p:cNvPr>
          <p:cNvGrpSpPr/>
          <p:nvPr/>
        </p:nvGrpSpPr>
        <p:grpSpPr>
          <a:xfrm>
            <a:off x="153773" y="326870"/>
            <a:ext cx="11614894" cy="4616580"/>
            <a:chOff x="153773" y="326870"/>
            <a:chExt cx="11614894" cy="4616580"/>
          </a:xfrm>
        </p:grpSpPr>
        <p:pic>
          <p:nvPicPr>
            <p:cNvPr id="7" name="Picture 6" descr="A close up of a child&#10;&#10;Description automatically generated with medium confidence">
              <a:extLst>
                <a:ext uri="{FF2B5EF4-FFF2-40B4-BE49-F238E27FC236}">
                  <a16:creationId xmlns:a16="http://schemas.microsoft.com/office/drawing/2014/main" id="{A94B61D2-0402-44F3-BD34-B27185737A1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3773" y="2750683"/>
              <a:ext cx="2192767" cy="2192767"/>
            </a:xfrm>
            <a:prstGeom prst="rect">
              <a:avLst/>
            </a:prstGeom>
          </p:spPr>
        </p:pic>
        <p:pic>
          <p:nvPicPr>
            <p:cNvPr id="9" name="Picture 8" descr="A close-up of a child&#10;&#10;Description automatically generated with medium confidence">
              <a:extLst>
                <a:ext uri="{FF2B5EF4-FFF2-40B4-BE49-F238E27FC236}">
                  <a16:creationId xmlns:a16="http://schemas.microsoft.com/office/drawing/2014/main" id="{EFE072A5-CD8A-4CA2-83FA-829E8CC65C1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40000" y="2750683"/>
              <a:ext cx="2192767" cy="2192767"/>
            </a:xfrm>
            <a:prstGeom prst="rect">
              <a:avLst/>
            </a:prstGeom>
          </p:spPr>
        </p:pic>
        <p:pic>
          <p:nvPicPr>
            <p:cNvPr id="11" name="Picture 10" descr="A close up of a person&#10;&#10;Description automatically generated with medium confidence">
              <a:extLst>
                <a:ext uri="{FF2B5EF4-FFF2-40B4-BE49-F238E27FC236}">
                  <a16:creationId xmlns:a16="http://schemas.microsoft.com/office/drawing/2014/main" id="{1694E38A-92C0-4702-B848-7FC9388AC59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85300" y="2750683"/>
              <a:ext cx="2192767" cy="2192767"/>
            </a:xfrm>
            <a:prstGeom prst="rect">
              <a:avLst/>
            </a:prstGeom>
          </p:spPr>
        </p:pic>
        <p:pic>
          <p:nvPicPr>
            <p:cNvPr id="13" name="Picture 12" descr="A close up of a child&#10;&#10;Description automatically generated with medium confidence">
              <a:extLst>
                <a:ext uri="{FF2B5EF4-FFF2-40B4-BE49-F238E27FC236}">
                  <a16:creationId xmlns:a16="http://schemas.microsoft.com/office/drawing/2014/main" id="{3D07FB3D-8DC3-441A-AEEE-1FA7725A497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230600" y="2750683"/>
              <a:ext cx="2192767" cy="2192767"/>
            </a:xfrm>
            <a:prstGeom prst="rect">
              <a:avLst/>
            </a:prstGeom>
          </p:spPr>
        </p:pic>
        <p:pic>
          <p:nvPicPr>
            <p:cNvPr id="15" name="Picture 14" descr="A picture containing person, indoor, smiling, posing&#10;&#10;Description automatically generated">
              <a:extLst>
                <a:ext uri="{FF2B5EF4-FFF2-40B4-BE49-F238E27FC236}">
                  <a16:creationId xmlns:a16="http://schemas.microsoft.com/office/drawing/2014/main" id="{AAD6EE75-6A46-4CDC-9B19-4C4A6B06EE3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575900" y="2750683"/>
              <a:ext cx="2192767" cy="2192767"/>
            </a:xfrm>
            <a:prstGeom prst="rect">
              <a:avLst/>
            </a:prstGeom>
          </p:spPr>
        </p:pic>
        <p:pic>
          <p:nvPicPr>
            <p:cNvPr id="17" name="Picture 16" descr="A close up of a child&#10;&#10;Description automatically generated with medium confidence">
              <a:extLst>
                <a:ext uri="{FF2B5EF4-FFF2-40B4-BE49-F238E27FC236}">
                  <a16:creationId xmlns:a16="http://schemas.microsoft.com/office/drawing/2014/main" id="{77BAB4A9-C4D1-4A5A-BFA3-BF5AFEC694CB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3773" y="326870"/>
              <a:ext cx="2192767" cy="2192767"/>
            </a:xfrm>
            <a:prstGeom prst="rect">
              <a:avLst/>
            </a:prstGeom>
          </p:spPr>
        </p:pic>
        <p:pic>
          <p:nvPicPr>
            <p:cNvPr id="19" name="Picture 18" descr="A close-up of a child&#10;&#10;Description automatically generated with medium confidence">
              <a:extLst>
                <a:ext uri="{FF2B5EF4-FFF2-40B4-BE49-F238E27FC236}">
                  <a16:creationId xmlns:a16="http://schemas.microsoft.com/office/drawing/2014/main" id="{F553FD21-4D79-4217-A314-6D465FA7B398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40000" y="326870"/>
              <a:ext cx="2192767" cy="2192767"/>
            </a:xfrm>
            <a:prstGeom prst="rect">
              <a:avLst/>
            </a:prstGeom>
          </p:spPr>
        </p:pic>
        <p:pic>
          <p:nvPicPr>
            <p:cNvPr id="21" name="Picture 20" descr="A close-up of a person smiling&#10;&#10;Description automatically generated">
              <a:extLst>
                <a:ext uri="{FF2B5EF4-FFF2-40B4-BE49-F238E27FC236}">
                  <a16:creationId xmlns:a16="http://schemas.microsoft.com/office/drawing/2014/main" id="{8DAE43CB-CF6D-4CFB-87ED-96B022A671EE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85234" y="326870"/>
              <a:ext cx="2192767" cy="2192767"/>
            </a:xfrm>
            <a:prstGeom prst="rect">
              <a:avLst/>
            </a:prstGeom>
          </p:spPr>
        </p:pic>
        <p:pic>
          <p:nvPicPr>
            <p:cNvPr id="23" name="Picture 22" descr="A close-up of a person smiling&#10;&#10;Description automatically generated">
              <a:extLst>
                <a:ext uri="{FF2B5EF4-FFF2-40B4-BE49-F238E27FC236}">
                  <a16:creationId xmlns:a16="http://schemas.microsoft.com/office/drawing/2014/main" id="{C1886B9D-A0E6-4AD6-AE3D-FDD8D4D4294F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230600" y="326871"/>
              <a:ext cx="2192767" cy="2192767"/>
            </a:xfrm>
            <a:prstGeom prst="rect">
              <a:avLst/>
            </a:prstGeom>
          </p:spPr>
        </p:pic>
        <p:pic>
          <p:nvPicPr>
            <p:cNvPr id="25" name="Picture 24" descr="A picture containing person, indoor, smiling, posing&#10;&#10;Description automatically generated">
              <a:extLst>
                <a:ext uri="{FF2B5EF4-FFF2-40B4-BE49-F238E27FC236}">
                  <a16:creationId xmlns:a16="http://schemas.microsoft.com/office/drawing/2014/main" id="{67E44B4A-5477-4BB1-B95B-E8967BE76CC6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575834" y="326870"/>
              <a:ext cx="2192767" cy="2192767"/>
            </a:xfrm>
            <a:prstGeom prst="rect">
              <a:avLst/>
            </a:prstGeom>
          </p:spPr>
        </p:pic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4CE7DBB0-C3E7-4E30-9279-100C6DBD216C}"/>
              </a:ext>
            </a:extLst>
          </p:cNvPr>
          <p:cNvSpPr txBox="1"/>
          <p:nvPr/>
        </p:nvSpPr>
        <p:spPr>
          <a:xfrm>
            <a:off x="307699" y="-3142"/>
            <a:ext cx="2743200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.</a:t>
            </a:r>
          </a:p>
        </p:txBody>
      </p:sp>
    </p:spTree>
    <p:extLst>
      <p:ext uri="{BB962C8B-B14F-4D97-AF65-F5344CB8AC3E}">
        <p14:creationId xmlns:p14="http://schemas.microsoft.com/office/powerpoint/2010/main" val="1311135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8167CF01DBF90498E7A526AA8CF1A8C" ma:contentTypeVersion="9" ma:contentTypeDescription="Create a new document." ma:contentTypeScope="" ma:versionID="85033436ad1cb0adba3fb83f1ca9a00d">
  <xsd:schema xmlns:xsd="http://www.w3.org/2001/XMLSchema" xmlns:xs="http://www.w3.org/2001/XMLSchema" xmlns:p="http://schemas.microsoft.com/office/2006/metadata/properties" xmlns:ns2="8b25db39-86db-462c-bb85-f3ea4045ad49" xmlns:ns3="f4d5f980-7402-491b-a3c1-a3298e9cc04b" targetNamespace="http://schemas.microsoft.com/office/2006/metadata/properties" ma:root="true" ma:fieldsID="5012f291c9061c4eba65e332886de812" ns2:_="" ns3:_="">
    <xsd:import namespace="8b25db39-86db-462c-bb85-f3ea4045ad49"/>
    <xsd:import namespace="f4d5f980-7402-491b-a3c1-a3298e9cc04b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2:MediaServiceOCR" minOccurs="0"/>
                <xsd:element ref="ns2:MediaServiceDateTaken" minOccurs="0"/>
                <xsd:element ref="ns3:SharedWithUsers" minOccurs="0"/>
                <xsd:element ref="ns3:SharedWithDetail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b25db39-86db-462c-bb85-f3ea4045ad4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GenerationTime" ma:index="11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2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4" nillable="true" ma:displayName="MediaServiceDateTaken" ma:hidden="true" ma:internalName="MediaServiceDateTake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4d5f980-7402-491b-a3c1-a3298e9cc04b" elementFormDefault="qualified">
    <xsd:import namespace="http://schemas.microsoft.com/office/2006/documentManagement/types"/>
    <xsd:import namespace="http://schemas.microsoft.com/office/infopath/2007/PartnerControls"/>
    <xsd:element name="SharedWithUsers" ma:index="15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6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F8C17BBD-E79A-47B9-A8A8-F1A941F0FA7D}">
  <ds:schemaRefs>
    <ds:schemaRef ds:uri="http://schemas.microsoft.com/office/2006/metadata/properties"/>
    <ds:schemaRef ds:uri="http://schemas.microsoft.com/office/infopath/2007/PartnerControls"/>
  </ds:schemaRefs>
</ds:datastoreItem>
</file>

<file path=customXml/itemProps2.xml><?xml version="1.0" encoding="utf-8"?>
<ds:datastoreItem xmlns:ds="http://schemas.openxmlformats.org/officeDocument/2006/customXml" ds:itemID="{3B503929-AFEF-4406-A019-DFD2B72322CE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D0BA0790-4006-4468-9FC3-15A3A2D6448C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b25db39-86db-462c-bb85-f3ea4045ad49"/>
    <ds:schemaRef ds:uri="f4d5f980-7402-491b-a3c1-a3298e9cc04b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35</Words>
  <Application>Microsoft Office PowerPoint</Application>
  <PresentationFormat>Widescreen</PresentationFormat>
  <Paragraphs>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ikel, Rebekah (NIH/NHGRI) [E]</dc:creator>
  <cp:lastModifiedBy>Waikel, Rebekah (NIH/NHGRI) [E]</cp:lastModifiedBy>
  <cp:revision>7</cp:revision>
  <dcterms:created xsi:type="dcterms:W3CDTF">2021-12-08T20:40:49Z</dcterms:created>
  <dcterms:modified xsi:type="dcterms:W3CDTF">2022-02-22T23:34:2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8167CF01DBF90498E7A526AA8CF1A8C</vt:lpwstr>
  </property>
</Properties>
</file>